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7" r:id="rId2"/>
  </p:sldIdLst>
  <p:sldSz cx="6858000" cy="9906000" type="A4"/>
  <p:notesSz cx="6797675" cy="9926638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D5D5D"/>
    <a:srgbClr val="00CCFF"/>
    <a:srgbClr val="EAEF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799B23B-EC83-4686-B30A-512413B5E67A}" styleName="浅色样式 3 - 强调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26" autoAdjust="0"/>
    <p:restoredTop sz="94424" autoAdjust="0"/>
  </p:normalViewPr>
  <p:slideViewPr>
    <p:cSldViewPr snapToGrid="0">
      <p:cViewPr>
        <p:scale>
          <a:sx n="200" d="100"/>
          <a:sy n="200" d="100"/>
        </p:scale>
        <p:origin x="-978" y="-30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4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19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4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190"/>
            </a:lvl1pPr>
          </a:lstStyle>
          <a:p>
            <a:fld id="{0F9B84EA-7D68-4D60-9CB1-D50884785D1C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428281"/>
            <a:ext cx="2945659" cy="49803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19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50443" y="9428281"/>
            <a:ext cx="2945659" cy="49803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190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554014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8167BA-00AE-4330-A90C-0A71427533EC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E3AC74-90A7-43DF-A71E-EA7C84960C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079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F50B31-F62E-4A24-B055-04F35EF6EE19}" type="datetimeFigureOut">
              <a:rPr lang="zh-CN" altLang="en-US" smtClean="0"/>
              <a:t>2019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6738C-CB6A-46A9-B03A-383A76EF2AC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9181944"/>
              </p:ext>
            </p:extLst>
          </p:nvPr>
        </p:nvGraphicFramePr>
        <p:xfrm>
          <a:off x="499745" y="331470"/>
          <a:ext cx="3553833" cy="294513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92910"/>
                <a:gridCol w="457200"/>
                <a:gridCol w="472440"/>
                <a:gridCol w="441960"/>
                <a:gridCol w="489323"/>
              </a:tblGrid>
              <a:tr h="495300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5 </a:t>
                      </a:r>
                      <a:r>
                        <a:rPr lang="en-US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 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racteristics of 238 RCC patients according to P2RX6 expression levels.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1907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</a:rPr>
                        <a:t>Variabl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P2RX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 smtClean="0">
                          <a:effectLst/>
                        </a:rPr>
                        <a:t>X</a:t>
                      </a:r>
                      <a:r>
                        <a:rPr lang="en-US" sz="1100" b="1" u="none" strike="noStrike" baseline="30000" dirty="0" smtClean="0">
                          <a:effectLst/>
                        </a:rPr>
                        <a:t>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effectLst/>
                        </a:rPr>
                        <a:t>P</a:t>
                      </a:r>
                      <a:r>
                        <a:rPr lang="en-US" sz="1100" b="1" u="none" strike="noStrike" dirty="0">
                          <a:effectLst/>
                        </a:rPr>
                        <a:t> </a:t>
                      </a:r>
                      <a:r>
                        <a:rPr lang="en-US" sz="1100" b="1" u="none" strike="noStrike" dirty="0" smtClean="0">
                          <a:effectLst/>
                        </a:rPr>
                        <a:t>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Lo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Hig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CN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All cas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119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119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Age, years, &gt;60:&gt;=6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49:7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44:75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0.441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u="none" strike="noStrike" dirty="0">
                          <a:effectLst/>
                        </a:rPr>
                        <a:t>0.507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Gender, male/fe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83:36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71:48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2.649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u="none" strike="noStrike" dirty="0">
                          <a:effectLst/>
                        </a:rPr>
                        <a:t>0.135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Tumor Size(cm), &lt;=4:&gt;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92:27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81:38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2.561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u="none" strike="noStrike" dirty="0">
                          <a:effectLst/>
                        </a:rPr>
                        <a:t>0.110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</a:tr>
              <a:tr h="1009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 Stage, T1-2/T3-4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smtClean="0">
                          <a:effectLst/>
                        </a:rPr>
                        <a:t>96:2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smtClean="0">
                          <a:effectLst/>
                        </a:rPr>
                        <a:t>76:4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smtClean="0">
                          <a:effectLst/>
                        </a:rPr>
                        <a:t>8.386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u="none" strike="noStrike" dirty="0" smtClean="0">
                          <a:effectLst/>
                        </a:rPr>
                        <a:t>0.004**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Tumor Side, Left/Righ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53:66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54:6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0.017 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u="none" strike="noStrike" dirty="0">
                          <a:effectLst/>
                        </a:rPr>
                        <a:t>0.896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Fuhrman, I-II/III-I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95:24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smtClean="0">
                          <a:effectLst/>
                        </a:rPr>
                        <a:t>81:38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4.275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u="none" strike="noStrike" dirty="0">
                          <a:effectLst/>
                        </a:rPr>
                        <a:t>0.039*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tastasis, Negative/Positiv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103:16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89:3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5.282 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u="none" strike="noStrike" dirty="0">
                          <a:effectLst/>
                        </a:rPr>
                        <a:t>0.022*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</a:tr>
              <a:tr h="561975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For P2RX6 expression, median values were used as the cut-off point for definition of subgroups (low expression and high expression groups, detail data could be seen in Table </a:t>
                      </a:r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S4). </a:t>
                      </a:r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P value from Chi-square test. (* P &lt; 0.05, ** P &lt; 0.01).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20046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41</TotalTime>
  <Words>137</Words>
  <Application>Microsoft Office PowerPoint</Application>
  <PresentationFormat>A4 纸张(210x297 毫米)</PresentationFormat>
  <Paragraphs>4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k gong</dc:creator>
  <cp:lastModifiedBy>Gong DK</cp:lastModifiedBy>
  <cp:revision>420</cp:revision>
  <cp:lastPrinted>2018-09-03T11:38:00Z</cp:lastPrinted>
  <dcterms:created xsi:type="dcterms:W3CDTF">2018-03-11T20:34:00Z</dcterms:created>
  <dcterms:modified xsi:type="dcterms:W3CDTF">2019-04-18T03:34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7849</vt:lpwstr>
  </property>
</Properties>
</file>